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4" autoAdjust="0"/>
    <p:restoredTop sz="94660"/>
  </p:normalViewPr>
  <p:slideViewPr>
    <p:cSldViewPr snapToGrid="0">
      <p:cViewPr>
        <p:scale>
          <a:sx n="86" d="100"/>
          <a:sy n="86" d="100"/>
        </p:scale>
        <p:origin x="654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ACE84-EDAE-4B3F-A505-44EA4282F7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DCD742-9999-4D03-882C-7F7C04A6BA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21008D-54A4-44B6-9FFE-4D6D7415B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15C5BD-F146-4CAA-960B-03E1821B0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25B0FB-BFF4-4C6E-AF63-516134F27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5600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CACDA-33B9-44BB-BD1C-D80C319AE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1EF1B0-9778-45AD-BA2F-E916D8B98E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5BA05F-08A6-408D-908C-94026F107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A67D1B-15A8-4C5C-A669-EBFF739B1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E16903-8DC8-4986-9E5B-8A677E47D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1396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321A86-8256-45B1-BA40-61F0A0F306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8AAF0B-6521-4198-BCA2-3C8CF357AE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BD07D7-1A59-4217-B3C7-F2B4F823D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7E6E79-91B7-46BE-BCE5-2C851DCE0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F21625-7461-4F48-9862-205B1E604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803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2EA9E-BF97-4ADF-A534-5389F148F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BB3CDB-5AE8-4D1E-B829-D0B66FB2EC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8FBAE-FFD3-4CD0-8687-695FD2DCC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E54A6-1D04-4268-A632-DD1385089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379978-251F-4E80-AB8B-E261A2400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9627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06F1A-C6BB-469B-A4BE-827260A82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35BF11-C693-4CE2-A41E-B7CB1BF03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73728-C9F2-4732-83A4-CC4B407EB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BE278-531A-4438-AAF7-0EB736D82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98C7AE-2C0F-48CC-969B-8D2D2EE03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9006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57138-E849-4EB0-983F-32BC26987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FC3793-0A82-43DF-9707-2CC61DC366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C65858-7B94-4DD0-902B-877C2D69E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85E1B8-EB00-4B55-ABEF-653570CF5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BC1045-3468-4E61-B5BD-92A5F1246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6533E4-25E3-4F38-ADC5-6CBD52AE4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0739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863C0-0FC2-47D6-A7B8-CBC18BC7F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165D62-44C0-44D0-9EFC-2CE60E43E7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B80CD0-C95A-4023-887A-2AED26B544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D99341-34CE-411C-9975-092CA23AE8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6219CE-2D01-4959-8DF9-C7F57E0EA1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6321BD1-AECA-4D88-BDDD-12D6CF7EE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806039-6FDB-4193-88B2-DF86EF833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7FEB7B-C87F-44F5-80F3-49DD78115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3333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A644F-3060-405A-9ADB-038EDB26A5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EFCC54-6C27-4A04-AA07-5C805E1A4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BB4B32-6ECE-4262-8246-F182D3A98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347A34-A477-43B0-89B3-C5F3C01A4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3468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EF2CC5-1B43-4413-9EC1-62F6288A4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2FBDD1-C045-4187-8ABD-FF99ED23B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E6B4B3-3A78-45F7-BEDC-59A82CA6B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4728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80A65-5508-4867-8892-BA9F4F0835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8223F-0B75-4670-8E3B-90CA757EA6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571AAE-060E-4CEA-BB06-7C4E649DC7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DBA881-5B6C-491F-A33A-66CF2C9E2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EBEB69-FC53-4930-BEF8-48E69E1AC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68866E-3705-4604-9239-7E9E9A497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880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5BD51-28E8-4C07-A0A5-FD2E851E4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344FF4-B9E0-4C17-8E86-53FD4B4322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EF70AC-7891-4DA1-B84F-A6230B1B49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A230A-9E0E-40A0-91F0-EFCDD1C71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E2675B-4DDF-4ED3-B54D-DD110C23B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1F2920-E556-4222-BB5A-2A74E63C6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5358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76AFB7-4264-45E4-8BC2-4FCB5620CC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C5FA4-2260-4E2C-9AFC-ED206DAC4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657A2-E70A-45C0-BAB2-7DD6BF846F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756C2-E4EB-4389-B6E2-3925001ACA12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9A15CB-03A1-4171-BE53-00B5A923CE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2E7CED-9090-437C-BE70-F89E273DDC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02687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C7334AF2-A3D1-45D9-A8C2-272DBC5E8B84}"/>
              </a:ext>
            </a:extLst>
          </p:cNvPr>
          <p:cNvSpPr txBox="1"/>
          <p:nvPr/>
        </p:nvSpPr>
        <p:spPr>
          <a:xfrm>
            <a:off x="40510" y="77393"/>
            <a:ext cx="65950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ell lysate and supernatant - Coomassie stai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C958020-2A6A-4A4C-85F3-48EC357CB405}"/>
              </a:ext>
            </a:extLst>
          </p:cNvPr>
          <p:cNvSpPr txBox="1"/>
          <p:nvPr/>
        </p:nvSpPr>
        <p:spPr>
          <a:xfrm>
            <a:off x="5431875" y="148331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picture containing text, cabinet&#10;&#10;Description automatically generated">
            <a:extLst>
              <a:ext uri="{FF2B5EF4-FFF2-40B4-BE49-F238E27FC236}">
                <a16:creationId xmlns:a16="http://schemas.microsoft.com/office/drawing/2014/main" id="{80F401E8-A654-4F1C-BF7B-F520E4CF65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86"/>
          <a:stretch/>
        </p:blipFill>
        <p:spPr>
          <a:xfrm>
            <a:off x="5000913" y="1834221"/>
            <a:ext cx="6507805" cy="480291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2C6C35C7-AF33-4534-ADCA-F40A6D7A6144}"/>
              </a:ext>
            </a:extLst>
          </p:cNvPr>
          <p:cNvSpPr txBox="1"/>
          <p:nvPr/>
        </p:nvSpPr>
        <p:spPr>
          <a:xfrm rot="18677097">
            <a:off x="6302252" y="1127318"/>
            <a:ext cx="1744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CYC184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04F35AC-D500-477F-AF2D-CBFF1AD051E9}"/>
              </a:ext>
            </a:extLst>
          </p:cNvPr>
          <p:cNvSpPr txBox="1"/>
          <p:nvPr/>
        </p:nvSpPr>
        <p:spPr>
          <a:xfrm rot="18677097">
            <a:off x="6670300" y="1062874"/>
            <a:ext cx="19159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816860F-4B77-4870-8660-F33D50A36979}"/>
              </a:ext>
            </a:extLst>
          </p:cNvPr>
          <p:cNvSpPr txBox="1"/>
          <p:nvPr/>
        </p:nvSpPr>
        <p:spPr>
          <a:xfrm rot="18677097">
            <a:off x="6956073" y="848511"/>
            <a:ext cx="2486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F96E14B-5920-483C-AD21-94689FA36C83}"/>
              </a:ext>
            </a:extLst>
          </p:cNvPr>
          <p:cNvSpPr txBox="1"/>
          <p:nvPr/>
        </p:nvSpPr>
        <p:spPr>
          <a:xfrm rot="18677097">
            <a:off x="7341493" y="868338"/>
            <a:ext cx="24336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4FA63EA-A8EA-44D7-B344-60A9F293DFCC}"/>
              </a:ext>
            </a:extLst>
          </p:cNvPr>
          <p:cNvSpPr txBox="1"/>
          <p:nvPr/>
        </p:nvSpPr>
        <p:spPr>
          <a:xfrm rot="18677097">
            <a:off x="8284621" y="992759"/>
            <a:ext cx="1744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CYC18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B48BB4F-CD22-4D0B-BA26-B1BAFC81A7D7}"/>
              </a:ext>
            </a:extLst>
          </p:cNvPr>
          <p:cNvSpPr txBox="1"/>
          <p:nvPr/>
        </p:nvSpPr>
        <p:spPr>
          <a:xfrm rot="18677097">
            <a:off x="8652669" y="928315"/>
            <a:ext cx="19159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75F8810-9042-4BDD-843A-B5F8FB9E3438}"/>
              </a:ext>
            </a:extLst>
          </p:cNvPr>
          <p:cNvSpPr txBox="1"/>
          <p:nvPr/>
        </p:nvSpPr>
        <p:spPr>
          <a:xfrm rot="18677097">
            <a:off x="8938442" y="713952"/>
            <a:ext cx="2486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EA22862-E340-4F81-9427-04530E454521}"/>
              </a:ext>
            </a:extLst>
          </p:cNvPr>
          <p:cNvSpPr txBox="1"/>
          <p:nvPr/>
        </p:nvSpPr>
        <p:spPr>
          <a:xfrm rot="18677097">
            <a:off x="9323862" y="733779"/>
            <a:ext cx="24336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EBA40E5F-7718-4753-8067-6B2428591FAF}"/>
              </a:ext>
            </a:extLst>
          </p:cNvPr>
          <p:cNvGrpSpPr/>
          <p:nvPr/>
        </p:nvGrpSpPr>
        <p:grpSpPr>
          <a:xfrm>
            <a:off x="5618463" y="5102371"/>
            <a:ext cx="397773" cy="261610"/>
            <a:chOff x="1393024" y="3367982"/>
            <a:chExt cx="397773" cy="2616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80A93BB-8DA9-49FE-89E4-F4338016881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A35D8C2D-2C23-4B69-9746-04BA6FA1C4AC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83B9EA2-C8E8-462D-8967-9395481EAF41}"/>
              </a:ext>
            </a:extLst>
          </p:cNvPr>
          <p:cNvGrpSpPr/>
          <p:nvPr/>
        </p:nvGrpSpPr>
        <p:grpSpPr>
          <a:xfrm>
            <a:off x="5623702" y="4376256"/>
            <a:ext cx="397773" cy="261610"/>
            <a:chOff x="1311020" y="3006632"/>
            <a:chExt cx="397773" cy="26161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2C27D1B-2202-4377-8A0F-01B142A77714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E09A941-7DB7-4DE2-B4A4-A3A6C6105ED5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9C0F3B00-952A-4D50-9CBB-612AF99E2DBD}"/>
              </a:ext>
            </a:extLst>
          </p:cNvPr>
          <p:cNvGrpSpPr/>
          <p:nvPr/>
        </p:nvGrpSpPr>
        <p:grpSpPr>
          <a:xfrm>
            <a:off x="5623702" y="4053336"/>
            <a:ext cx="397773" cy="261610"/>
            <a:chOff x="1311020" y="2832922"/>
            <a:chExt cx="397773" cy="261610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E2CA9AD-AC55-47C9-BE28-CDC6286ED57E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9D68C63C-F4E5-4E63-BED8-5BA349FA5FFC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A132F470-CEBD-44FB-B403-7A780523D219}"/>
              </a:ext>
            </a:extLst>
          </p:cNvPr>
          <p:cNvGrpSpPr/>
          <p:nvPr/>
        </p:nvGrpSpPr>
        <p:grpSpPr>
          <a:xfrm>
            <a:off x="5623702" y="3599611"/>
            <a:ext cx="392534" cy="261610"/>
            <a:chOff x="1316259" y="2597742"/>
            <a:chExt cx="392534" cy="261610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FD038F9-2237-4DCA-B768-7D6DBD44BA3E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E4735780-0889-40C6-86A8-B124703BC231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0C5A7313-46CA-4160-9AAB-C0F40611063A}"/>
              </a:ext>
            </a:extLst>
          </p:cNvPr>
          <p:cNvGrpSpPr/>
          <p:nvPr/>
        </p:nvGrpSpPr>
        <p:grpSpPr>
          <a:xfrm>
            <a:off x="5625109" y="3272599"/>
            <a:ext cx="392534" cy="261610"/>
            <a:chOff x="1316259" y="2425509"/>
            <a:chExt cx="392534" cy="261610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4930ED7-38E2-441D-992C-0ABEFEA579FE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64E4F9E-8EE6-444D-A2AB-C3A99783B693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E585315-3E75-4E1A-9F3B-1E498B26865F}"/>
              </a:ext>
            </a:extLst>
          </p:cNvPr>
          <p:cNvGrpSpPr/>
          <p:nvPr/>
        </p:nvGrpSpPr>
        <p:grpSpPr>
          <a:xfrm>
            <a:off x="5560747" y="2599977"/>
            <a:ext cx="455489" cy="261610"/>
            <a:chOff x="1250098" y="2063666"/>
            <a:chExt cx="455489" cy="261610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562799A-427A-4D81-85EF-C4E7F63A4F10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15D0090D-91A8-4143-90BC-004D8EEFBD4F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D847CC35-B8BA-4508-B21C-0BEE41223E87}"/>
              </a:ext>
            </a:extLst>
          </p:cNvPr>
          <p:cNvGrpSpPr/>
          <p:nvPr/>
        </p:nvGrpSpPr>
        <p:grpSpPr>
          <a:xfrm>
            <a:off x="5560747" y="2214115"/>
            <a:ext cx="455489" cy="261610"/>
            <a:chOff x="1254594" y="1899344"/>
            <a:chExt cx="455489" cy="261610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542F644-DB1B-4C78-949B-3E2C8FE8AA1C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FEC6000-4F99-4871-B0EF-69BF4E5340B2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322C2847-5967-4FA4-8397-1CA6F21326D2}"/>
              </a:ext>
            </a:extLst>
          </p:cNvPr>
          <p:cNvGrpSpPr/>
          <p:nvPr/>
        </p:nvGrpSpPr>
        <p:grpSpPr>
          <a:xfrm>
            <a:off x="5560747" y="2406944"/>
            <a:ext cx="455489" cy="261610"/>
            <a:chOff x="1254594" y="1899344"/>
            <a:chExt cx="455489" cy="261610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EB5C46E-AC69-469E-9F0F-F6E354B21DD5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EEC2BDE5-31B5-4C88-983B-48FF95874ADF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65CA6CFE-5E3C-4AD4-A858-C14F22F7AA06}"/>
              </a:ext>
            </a:extLst>
          </p:cNvPr>
          <p:cNvGrpSpPr/>
          <p:nvPr/>
        </p:nvGrpSpPr>
        <p:grpSpPr>
          <a:xfrm>
            <a:off x="5618463" y="5952921"/>
            <a:ext cx="397773" cy="261610"/>
            <a:chOff x="1393024" y="3367982"/>
            <a:chExt cx="397773" cy="261610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16DDFC5-1243-4056-BF36-52AF5688C9C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C6DBC49C-861C-444F-B5BC-5B8AEC051C86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CFFA1387-3EAB-4CA6-AB95-7295546D0CB9}"/>
              </a:ext>
            </a:extLst>
          </p:cNvPr>
          <p:cNvGrpSpPr/>
          <p:nvPr/>
        </p:nvGrpSpPr>
        <p:grpSpPr>
          <a:xfrm>
            <a:off x="5623702" y="2783650"/>
            <a:ext cx="392534" cy="253916"/>
            <a:chOff x="1316259" y="2425509"/>
            <a:chExt cx="392534" cy="253916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AA5D914-8499-49D1-9F54-064707E9F831}"/>
                </a:ext>
              </a:extLst>
            </p:cNvPr>
            <p:cNvSpPr txBox="1"/>
            <p:nvPr/>
          </p:nvSpPr>
          <p:spPr>
            <a:xfrm>
              <a:off x="1316259" y="2425509"/>
              <a:ext cx="3193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28A4FED2-3515-4FAB-98C9-815331197721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C69B01F-F5AA-4E5D-A078-7FDC3B6F3143}"/>
              </a:ext>
            </a:extLst>
          </p:cNvPr>
          <p:cNvSpPr txBox="1"/>
          <p:nvPr/>
        </p:nvSpPr>
        <p:spPr>
          <a:xfrm>
            <a:off x="6902997" y="648866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L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18EE957-0E91-4C85-85F2-2080578361C4}"/>
              </a:ext>
            </a:extLst>
          </p:cNvPr>
          <p:cNvSpPr txBox="1"/>
          <p:nvPr/>
        </p:nvSpPr>
        <p:spPr>
          <a:xfrm>
            <a:off x="8687843" y="6488668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</a:t>
            </a:r>
          </a:p>
        </p:txBody>
      </p:sp>
    </p:spTree>
    <p:extLst>
      <p:ext uri="{BB962C8B-B14F-4D97-AF65-F5344CB8AC3E}">
        <p14:creationId xmlns:p14="http://schemas.microsoft.com/office/powerpoint/2010/main" val="15274292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40AACC0-3B9A-49E8-B96A-531A0078EC5D}"/>
              </a:ext>
            </a:extLst>
          </p:cNvPr>
          <p:cNvCxnSpPr>
            <a:cxnSpLocks/>
          </p:cNvCxnSpPr>
          <p:nvPr/>
        </p:nvCxnSpPr>
        <p:spPr>
          <a:xfrm flipH="1">
            <a:off x="10228252" y="2326560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DDCC46E6-0B6D-4862-8542-F26D03146C70}"/>
              </a:ext>
            </a:extLst>
          </p:cNvPr>
          <p:cNvSpPr txBox="1"/>
          <p:nvPr/>
        </p:nvSpPr>
        <p:spPr>
          <a:xfrm>
            <a:off x="10665666" y="2095727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P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3870806-B519-430C-B390-535DF81AE768}"/>
              </a:ext>
            </a:extLst>
          </p:cNvPr>
          <p:cNvCxnSpPr>
            <a:cxnSpLocks/>
          </p:cNvCxnSpPr>
          <p:nvPr/>
        </p:nvCxnSpPr>
        <p:spPr>
          <a:xfrm flipH="1">
            <a:off x="10228252" y="5902812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5047FDF-2B2B-499F-9926-2AD73530097D}"/>
              </a:ext>
            </a:extLst>
          </p:cNvPr>
          <p:cNvSpPr txBox="1"/>
          <p:nvPr/>
        </p:nvSpPr>
        <p:spPr>
          <a:xfrm>
            <a:off x="10665666" y="5671979"/>
            <a:ext cx="8675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7334AF2-A3D1-45D9-A8C2-272DBC5E8B84}"/>
              </a:ext>
            </a:extLst>
          </p:cNvPr>
          <p:cNvSpPr txBox="1"/>
          <p:nvPr/>
        </p:nvSpPr>
        <p:spPr>
          <a:xfrm>
            <a:off x="5662" y="105667"/>
            <a:ext cx="6875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ell lysate – anti-RNAP and anti-</a:t>
            </a:r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EBA40E5F-7718-4753-8067-6B2428591FAF}"/>
              </a:ext>
            </a:extLst>
          </p:cNvPr>
          <p:cNvGrpSpPr/>
          <p:nvPr/>
        </p:nvGrpSpPr>
        <p:grpSpPr>
          <a:xfrm>
            <a:off x="6707645" y="5423820"/>
            <a:ext cx="397773" cy="261610"/>
            <a:chOff x="1393024" y="3367982"/>
            <a:chExt cx="397773" cy="2616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80A93BB-8DA9-49FE-89E4-F4338016881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A35D8C2D-2C23-4B69-9746-04BA6FA1C4AC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83B9EA2-C8E8-462D-8967-9395481EAF41}"/>
              </a:ext>
            </a:extLst>
          </p:cNvPr>
          <p:cNvGrpSpPr/>
          <p:nvPr/>
        </p:nvGrpSpPr>
        <p:grpSpPr>
          <a:xfrm>
            <a:off x="6705877" y="4622767"/>
            <a:ext cx="397773" cy="261610"/>
            <a:chOff x="1311020" y="3006632"/>
            <a:chExt cx="397773" cy="26161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2C27D1B-2202-4377-8A0F-01B142A77714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E09A941-7DB7-4DE2-B4A4-A3A6C6105ED5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9C0F3B00-952A-4D50-9CBB-612AF99E2DBD}"/>
              </a:ext>
            </a:extLst>
          </p:cNvPr>
          <p:cNvGrpSpPr/>
          <p:nvPr/>
        </p:nvGrpSpPr>
        <p:grpSpPr>
          <a:xfrm>
            <a:off x="6708280" y="4266530"/>
            <a:ext cx="397773" cy="261610"/>
            <a:chOff x="1311020" y="2832922"/>
            <a:chExt cx="397773" cy="261610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E2CA9AD-AC55-47C9-BE28-CDC6286ED57E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9D68C63C-F4E5-4E63-BED8-5BA349FA5FFC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A132F470-CEBD-44FB-B403-7A780523D219}"/>
              </a:ext>
            </a:extLst>
          </p:cNvPr>
          <p:cNvGrpSpPr/>
          <p:nvPr/>
        </p:nvGrpSpPr>
        <p:grpSpPr>
          <a:xfrm>
            <a:off x="6713520" y="3747754"/>
            <a:ext cx="392534" cy="261610"/>
            <a:chOff x="1316259" y="2597742"/>
            <a:chExt cx="392534" cy="261610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FD038F9-2237-4DCA-B768-7D6DBD44BA3E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E4735780-0889-40C6-86A8-B124703BC231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0C5A7313-46CA-4160-9AAB-C0F40611063A}"/>
              </a:ext>
            </a:extLst>
          </p:cNvPr>
          <p:cNvGrpSpPr/>
          <p:nvPr/>
        </p:nvGrpSpPr>
        <p:grpSpPr>
          <a:xfrm>
            <a:off x="6713520" y="3393837"/>
            <a:ext cx="392534" cy="261610"/>
            <a:chOff x="1316259" y="2425509"/>
            <a:chExt cx="392534" cy="261610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4930ED7-38E2-441D-992C-0ABEFEA579FE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64E4F9E-8EE6-444D-A2AB-C3A99783B693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E585315-3E75-4E1A-9F3B-1E498B26865F}"/>
              </a:ext>
            </a:extLst>
          </p:cNvPr>
          <p:cNvGrpSpPr/>
          <p:nvPr/>
        </p:nvGrpSpPr>
        <p:grpSpPr>
          <a:xfrm>
            <a:off x="6650994" y="2632802"/>
            <a:ext cx="455489" cy="261610"/>
            <a:chOff x="1250098" y="2063666"/>
            <a:chExt cx="455489" cy="261610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562799A-427A-4D81-85EF-C4E7F63A4F10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15D0090D-91A8-4143-90BC-004D8EEFBD4F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D847CC35-B8BA-4508-B21C-0BEE41223E87}"/>
              </a:ext>
            </a:extLst>
          </p:cNvPr>
          <p:cNvGrpSpPr/>
          <p:nvPr/>
        </p:nvGrpSpPr>
        <p:grpSpPr>
          <a:xfrm>
            <a:off x="6649431" y="2184588"/>
            <a:ext cx="455489" cy="261610"/>
            <a:chOff x="1254594" y="1899344"/>
            <a:chExt cx="455489" cy="261610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542F644-DB1B-4C78-949B-3E2C8FE8AA1C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FEC6000-4F99-4871-B0EF-69BF4E5340B2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322C2847-5967-4FA4-8397-1CA6F21326D2}"/>
              </a:ext>
            </a:extLst>
          </p:cNvPr>
          <p:cNvGrpSpPr/>
          <p:nvPr/>
        </p:nvGrpSpPr>
        <p:grpSpPr>
          <a:xfrm>
            <a:off x="6653059" y="2377417"/>
            <a:ext cx="455489" cy="261610"/>
            <a:chOff x="1254594" y="1899344"/>
            <a:chExt cx="455489" cy="261610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EB5C46E-AC69-469E-9F0F-F6E354B21DD5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EEC2BDE5-31B5-4C88-983B-48FF95874ADF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AC958020-2A6A-4A4C-85F3-48EC357CB405}"/>
              </a:ext>
            </a:extLst>
          </p:cNvPr>
          <p:cNvSpPr txBox="1"/>
          <p:nvPr/>
        </p:nvSpPr>
        <p:spPr>
          <a:xfrm>
            <a:off x="6242084" y="157559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65CA6CFE-5E3C-4AD4-A858-C14F22F7AA06}"/>
              </a:ext>
            </a:extLst>
          </p:cNvPr>
          <p:cNvGrpSpPr/>
          <p:nvPr/>
        </p:nvGrpSpPr>
        <p:grpSpPr>
          <a:xfrm>
            <a:off x="6713520" y="6351122"/>
            <a:ext cx="397773" cy="261610"/>
            <a:chOff x="1393024" y="3367982"/>
            <a:chExt cx="397773" cy="261610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16DDFC5-1243-4056-BF36-52AF5688C9C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C6DBC49C-861C-444F-B5BC-5B8AEC051C86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75990971-766D-4983-9838-3684848D00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7187" y="1706181"/>
            <a:ext cx="3099356" cy="5151819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E8B89397-9115-48F2-9A94-2AA41A900B70}"/>
              </a:ext>
            </a:extLst>
          </p:cNvPr>
          <p:cNvSpPr txBox="1"/>
          <p:nvPr/>
        </p:nvSpPr>
        <p:spPr>
          <a:xfrm rot="18677097">
            <a:off x="7707306" y="1026367"/>
            <a:ext cx="1744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CYC18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F67EE98-9830-4AD7-8BF9-95A7B806D939}"/>
              </a:ext>
            </a:extLst>
          </p:cNvPr>
          <p:cNvSpPr txBox="1"/>
          <p:nvPr/>
        </p:nvSpPr>
        <p:spPr>
          <a:xfrm rot="18677097">
            <a:off x="8075354" y="961923"/>
            <a:ext cx="19159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818EFEE-98BE-48E1-B49C-033A52D15530}"/>
              </a:ext>
            </a:extLst>
          </p:cNvPr>
          <p:cNvSpPr txBox="1"/>
          <p:nvPr/>
        </p:nvSpPr>
        <p:spPr>
          <a:xfrm rot="18677097">
            <a:off x="8361127" y="747560"/>
            <a:ext cx="2486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0551B3E-946E-4483-A28D-48984E2F23E3}"/>
              </a:ext>
            </a:extLst>
          </p:cNvPr>
          <p:cNvSpPr txBox="1"/>
          <p:nvPr/>
        </p:nvSpPr>
        <p:spPr>
          <a:xfrm rot="18677097">
            <a:off x="8746547" y="767387"/>
            <a:ext cx="24336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501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470E9C7-9783-4D11-A58A-C101808610B7}"/>
              </a:ext>
            </a:extLst>
          </p:cNvPr>
          <p:cNvSpPr txBox="1"/>
          <p:nvPr/>
        </p:nvSpPr>
        <p:spPr>
          <a:xfrm>
            <a:off x="5662" y="105667"/>
            <a:ext cx="43172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– anti-</a:t>
            </a:r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CA71BE7-5D3C-47AD-AA7F-10A43478A837}"/>
              </a:ext>
            </a:extLst>
          </p:cNvPr>
          <p:cNvCxnSpPr>
            <a:cxnSpLocks/>
          </p:cNvCxnSpPr>
          <p:nvPr/>
        </p:nvCxnSpPr>
        <p:spPr>
          <a:xfrm flipH="1">
            <a:off x="9959461" y="5926297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73ECCD1-DF3C-4FEA-ADD0-5CF45A08242B}"/>
              </a:ext>
            </a:extLst>
          </p:cNvPr>
          <p:cNvSpPr txBox="1"/>
          <p:nvPr/>
        </p:nvSpPr>
        <p:spPr>
          <a:xfrm>
            <a:off x="10396875" y="5695464"/>
            <a:ext cx="8675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A3B0C79-4A88-4E74-9BA8-58A3A57293FE}"/>
              </a:ext>
            </a:extLst>
          </p:cNvPr>
          <p:cNvGrpSpPr/>
          <p:nvPr/>
        </p:nvGrpSpPr>
        <p:grpSpPr>
          <a:xfrm>
            <a:off x="6059888" y="5499737"/>
            <a:ext cx="397773" cy="261610"/>
            <a:chOff x="1393024" y="3367982"/>
            <a:chExt cx="397773" cy="261610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AECC68F-131D-43B6-BC90-27374F898E08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F2797949-D434-4D08-972F-E6DDED1D0EBB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0197F452-13F5-4701-9614-02D8EF773ABD}"/>
              </a:ext>
            </a:extLst>
          </p:cNvPr>
          <p:cNvGrpSpPr/>
          <p:nvPr/>
        </p:nvGrpSpPr>
        <p:grpSpPr>
          <a:xfrm>
            <a:off x="6067025" y="4736868"/>
            <a:ext cx="397773" cy="261610"/>
            <a:chOff x="1311020" y="3006632"/>
            <a:chExt cx="397773" cy="26161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B0F1161-8814-4DD5-912F-9F9449945C25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21F29CD3-8C03-48AB-9D93-A960CE7FB857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123A6F6E-EBD8-4ADF-97A9-23A5557424C2}"/>
              </a:ext>
            </a:extLst>
          </p:cNvPr>
          <p:cNvGrpSpPr/>
          <p:nvPr/>
        </p:nvGrpSpPr>
        <p:grpSpPr>
          <a:xfrm>
            <a:off x="6073827" y="4345582"/>
            <a:ext cx="397773" cy="261610"/>
            <a:chOff x="1311020" y="2832922"/>
            <a:chExt cx="397773" cy="261610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049C074-0DD9-4386-B66F-D0809AB96348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FBBFE7C-7884-4AD7-A964-B48C038437C2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10173EF-A9FC-401F-8A01-5BD2BF0291F8}"/>
              </a:ext>
            </a:extLst>
          </p:cNvPr>
          <p:cNvGrpSpPr/>
          <p:nvPr/>
        </p:nvGrpSpPr>
        <p:grpSpPr>
          <a:xfrm>
            <a:off x="6079066" y="3910474"/>
            <a:ext cx="392534" cy="261610"/>
            <a:chOff x="1316259" y="2597742"/>
            <a:chExt cx="392534" cy="261610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8A79AA1-2E4F-48BF-A9F2-66359A5CA10D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039EE635-5820-434C-A07D-B62E612F7C00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3EC3BF74-8041-40AC-996A-D1659BC977B4}"/>
              </a:ext>
            </a:extLst>
          </p:cNvPr>
          <p:cNvGrpSpPr/>
          <p:nvPr/>
        </p:nvGrpSpPr>
        <p:grpSpPr>
          <a:xfrm>
            <a:off x="6067025" y="3553615"/>
            <a:ext cx="392534" cy="261610"/>
            <a:chOff x="1316259" y="2425509"/>
            <a:chExt cx="392534" cy="26161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3E8B811-0038-4C69-B3D9-3F5160C5DAE7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38563D2B-66C0-4BB0-A40A-9477CA476C9F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4A9BD8A-6EBF-490C-A0D2-2ED5514BCD39}"/>
              </a:ext>
            </a:extLst>
          </p:cNvPr>
          <p:cNvGrpSpPr/>
          <p:nvPr/>
        </p:nvGrpSpPr>
        <p:grpSpPr>
          <a:xfrm>
            <a:off x="5999638" y="2884486"/>
            <a:ext cx="455489" cy="261610"/>
            <a:chOff x="1250098" y="2063666"/>
            <a:chExt cx="455489" cy="261610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0D0037A-E0EE-4FD9-BAF1-682B9E22B602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B01A34C4-3207-448D-9556-F09BB83C0634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7C60028-6F82-4D96-A0AC-A1E6011868AC}"/>
              </a:ext>
            </a:extLst>
          </p:cNvPr>
          <p:cNvGrpSpPr/>
          <p:nvPr/>
        </p:nvGrpSpPr>
        <p:grpSpPr>
          <a:xfrm>
            <a:off x="6002933" y="2461833"/>
            <a:ext cx="455489" cy="261610"/>
            <a:chOff x="1254594" y="1899344"/>
            <a:chExt cx="455489" cy="261610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7A7B0C5-0835-43CE-A798-E9C441777AF6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136CB2B-2468-4ACA-A8C5-662B3BE22647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9EDCD704-2B65-4FAD-A5CD-B1CF76617794}"/>
              </a:ext>
            </a:extLst>
          </p:cNvPr>
          <p:cNvGrpSpPr/>
          <p:nvPr/>
        </p:nvGrpSpPr>
        <p:grpSpPr>
          <a:xfrm>
            <a:off x="6014460" y="2649691"/>
            <a:ext cx="455489" cy="261610"/>
            <a:chOff x="1254594" y="1899344"/>
            <a:chExt cx="455489" cy="2616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1F8980B-F49D-42F8-A5FF-15C434562AF5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A6D092A4-D720-4ECC-8922-3123C575ABEA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6414981F-A9E0-400A-A97D-C811A9E81BE1}"/>
              </a:ext>
            </a:extLst>
          </p:cNvPr>
          <p:cNvSpPr txBox="1"/>
          <p:nvPr/>
        </p:nvSpPr>
        <p:spPr>
          <a:xfrm>
            <a:off x="5741607" y="105128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75B02ABE-34DE-48F0-87B0-B36797724000}"/>
              </a:ext>
            </a:extLst>
          </p:cNvPr>
          <p:cNvGrpSpPr/>
          <p:nvPr/>
        </p:nvGrpSpPr>
        <p:grpSpPr>
          <a:xfrm>
            <a:off x="6059888" y="6372068"/>
            <a:ext cx="397773" cy="261610"/>
            <a:chOff x="1393024" y="3367982"/>
            <a:chExt cx="397773" cy="261610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7164CE7-2AB6-446F-8EF4-48C58B0F6967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78107E34-F6C8-484D-98FC-89A2D0634F6F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1" name="Picture 40" descr="A picture containing text, game&#10;&#10;Description automatically generated">
            <a:extLst>
              <a:ext uri="{FF2B5EF4-FFF2-40B4-BE49-F238E27FC236}">
                <a16:creationId xmlns:a16="http://schemas.microsoft.com/office/drawing/2014/main" id="{7DD785C2-428E-4DAD-99BF-FCFFF5B287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1935" y="1966423"/>
            <a:ext cx="2883938" cy="4891577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DA942A46-0E04-4728-8131-5BAB6F5F4CEC}"/>
              </a:ext>
            </a:extLst>
          </p:cNvPr>
          <p:cNvSpPr txBox="1"/>
          <p:nvPr/>
        </p:nvSpPr>
        <p:spPr>
          <a:xfrm rot="18677097">
            <a:off x="6786480" y="1115773"/>
            <a:ext cx="1744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CYC18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7EF7759-CD39-43A2-B5EB-C9FF3F316533}"/>
              </a:ext>
            </a:extLst>
          </p:cNvPr>
          <p:cNvSpPr txBox="1"/>
          <p:nvPr/>
        </p:nvSpPr>
        <p:spPr>
          <a:xfrm rot="18677097">
            <a:off x="7181186" y="1058958"/>
            <a:ext cx="19159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59F70CB-76A4-401D-BA47-959E28F16E94}"/>
              </a:ext>
            </a:extLst>
          </p:cNvPr>
          <p:cNvSpPr txBox="1"/>
          <p:nvPr/>
        </p:nvSpPr>
        <p:spPr>
          <a:xfrm rot="18677097">
            <a:off x="7545034" y="836965"/>
            <a:ext cx="2486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4558BDD-9863-4FB7-94FD-C1CB5A0F1DED}"/>
              </a:ext>
            </a:extLst>
          </p:cNvPr>
          <p:cNvSpPr txBox="1"/>
          <p:nvPr/>
        </p:nvSpPr>
        <p:spPr>
          <a:xfrm rot="18677097">
            <a:off x="8012708" y="856792"/>
            <a:ext cx="24336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CYC-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  <a:endParaRPr lang="en-AU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5885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16</Words>
  <Application>Microsoft Office PowerPoint</Application>
  <PresentationFormat>Widescreen</PresentationFormat>
  <Paragraphs>5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Icke</dc:creator>
  <cp:lastModifiedBy>Chris Icke</cp:lastModifiedBy>
  <cp:revision>7</cp:revision>
  <dcterms:created xsi:type="dcterms:W3CDTF">2020-12-04T03:33:27Z</dcterms:created>
  <dcterms:modified xsi:type="dcterms:W3CDTF">2020-12-22T03:46:58Z</dcterms:modified>
</cp:coreProperties>
</file>